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6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8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F75AD-15DA-28F5-AF9E-4144254E4C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4C370A0-B32C-CD27-01FD-261FE12A0C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4B86A5-EB59-9C4E-806F-27BDB12B4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4761A-4E60-B693-F3E3-A5B00AB3A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6EDD2-9830-D35B-926B-D9F4BB198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200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CD862-BE3C-EFC6-F862-C52A61BE0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20A89-0EFB-5343-2453-A755C0F717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821AA-C8F5-A685-3294-BA0AB9CB8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0CD00-A29C-8109-1B5C-B6342CC5A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D0BA4-831B-9CC1-6991-324104632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913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3D4E77-BC92-3B13-1730-1915A29182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4A74A1-BD09-8408-CB09-B0EC58D5EA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51CDD-AE3F-A802-8C3C-06B15F803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6AD905-9001-D0CB-7FB0-C51970041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4F8AF3-5A28-61B3-3DAD-90096E92E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693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BAA741-5540-9A31-3EA3-31111CCF1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2E08C-2AC8-B733-0425-7BA2F3EB86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6E4DFA-71E6-B408-151D-8ACA25EA1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96D458-C2A4-FB6F-1B44-1FB347FFB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50ACB-1DF1-CB0C-C3FB-4F0D10520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60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BDFB9B-A079-B8CF-5F99-DDEEB2B69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1C370B-8A1E-FEA5-AFCC-870CEB7687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F3855-D412-7E60-7D90-D67D3BE6E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5FA55-DE3F-B984-66DA-720CC2052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5AA25F-7371-4DFD-CFBF-BDDDEE17D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992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5C57B-203E-E20C-C89D-CB50A27289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42E36D-5C3A-5664-4AF1-7CD374EDFD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110D37-0566-D89F-4431-D241D13642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B2C836-13DA-668F-0CBF-7A5750937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6AA78C-187F-42F0-4074-024AC4A4D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68AD5-A07C-B41F-6035-EDC4B3F3D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066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27077-4172-9DE8-96D3-152FAB8E4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6FAF2B-3ECC-134C-231A-C8DEFC394F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A3C7DC-4910-3AF0-3B29-A4AABD98BA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1C09D8-B3DF-D31D-362E-9C2CD6C76E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2EB352-B1BF-096F-B2CD-F08C335ADE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E008DF-B908-7BE7-9EF4-E8BD873C6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8B3438-1751-AA43-0603-E95363C33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DFC612-D7B2-A000-2BD8-327D0289D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371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2EA37E-5C9F-62D3-8DB0-24BB1A909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BD4200-AEA6-24CD-15E3-31081E9B6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5A4970-E999-3F04-0D38-3AB30D866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AA2652-0EC2-1DE5-46BF-49752F763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705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C93DB9-65EF-8592-CA72-6C53C8FBC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B5DAF7-B227-370B-724A-A4144110B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028514-F140-21EE-30B4-66B5A8EC9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45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9B243-C3C8-9D97-3D76-C962D44A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745EB-68F8-1CB3-C738-4FFEAFFFF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CE3FDC-6765-B655-8CF5-C6A4D743FA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0C3EAC-C662-EBCF-EEF3-CC502320B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6C87C9-8BE1-B205-F0B6-A609C46D4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B1E2A-9B74-0ACA-1B84-D6D223AAB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66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2B6AD-ECC6-6E07-05B9-16E283111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728AF1-985A-1B66-80C3-4C4C842C2C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E680DE-10B3-06CF-4F1D-E779C1AFC0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D94C8F-B59C-6ABC-10CC-8C11B64DC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CAB4B8-158F-8042-F60B-F3D19CE6A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13A24C-4B32-D4DE-0403-063FF3D4E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337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13B1FF-6B20-E338-C2C0-18B131F35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4A9E8-F5E2-F586-C56E-DF093F7E74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F7037-F30E-EBA5-CF3F-99DC45DDBD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B67060-B8EE-44F0-BE98-2BE3226553C5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3ECD6-A52B-91C1-F3CC-AA7D4D8E82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AB294-072F-8B9E-F3CC-731A3CE0E0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EE0B30-D137-454C-8CAB-A23C25F805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325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F599D7B-FB20-857F-3BFA-81473C6C99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6837" y="1621229"/>
            <a:ext cx="6353691" cy="39618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2B3463D-6219-630C-46DD-5A0BAB877A8B}"/>
              </a:ext>
            </a:extLst>
          </p:cNvPr>
          <p:cNvSpPr txBox="1"/>
          <p:nvPr/>
        </p:nvSpPr>
        <p:spPr>
          <a:xfrm>
            <a:off x="1151792" y="668215"/>
            <a:ext cx="3849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B BNPage proband </a:t>
            </a:r>
            <a:r>
              <a:rPr lang="en-US"/>
              <a:t>1 (R182Q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4072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EB0DD7A-92F8-4D1C-6512-E606A00A8A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7212" y="2147887"/>
            <a:ext cx="11077575" cy="256222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0F5EFEA-8FA0-B6A7-50B0-E095CCFEB50D}"/>
              </a:ext>
            </a:extLst>
          </p:cNvPr>
          <p:cNvSpPr/>
          <p:nvPr/>
        </p:nvSpPr>
        <p:spPr>
          <a:xfrm>
            <a:off x="1301262" y="2356338"/>
            <a:ext cx="1230923" cy="15562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70C683F-EBC5-C09F-0DEF-2524BDA3360E}"/>
              </a:ext>
            </a:extLst>
          </p:cNvPr>
          <p:cNvSpPr/>
          <p:nvPr/>
        </p:nvSpPr>
        <p:spPr>
          <a:xfrm>
            <a:off x="6201508" y="2341684"/>
            <a:ext cx="1230923" cy="15562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69D8CA-BE32-1C67-A854-7FD26741AE08}"/>
              </a:ext>
            </a:extLst>
          </p:cNvPr>
          <p:cNvSpPr txBox="1"/>
          <p:nvPr/>
        </p:nvSpPr>
        <p:spPr>
          <a:xfrm>
            <a:off x="1450057" y="1778554"/>
            <a:ext cx="93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F4D8F2-31FD-F80E-2542-CA5E88EEBF13}"/>
              </a:ext>
            </a:extLst>
          </p:cNvPr>
          <p:cNvSpPr txBox="1"/>
          <p:nvPr/>
        </p:nvSpPr>
        <p:spPr>
          <a:xfrm>
            <a:off x="6095999" y="1778554"/>
            <a:ext cx="12682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Proband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C0D9D3-3D6F-F251-C517-1859E28BB7C2}"/>
              </a:ext>
            </a:extLst>
          </p:cNvPr>
          <p:cNvSpPr txBox="1"/>
          <p:nvPr/>
        </p:nvSpPr>
        <p:spPr>
          <a:xfrm>
            <a:off x="448408" y="580292"/>
            <a:ext cx="1184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 I</a:t>
            </a:r>
          </a:p>
        </p:txBody>
      </p:sp>
    </p:spTree>
    <p:extLst>
      <p:ext uri="{BB962C8B-B14F-4D97-AF65-F5344CB8AC3E}">
        <p14:creationId xmlns:p14="http://schemas.microsoft.com/office/powerpoint/2010/main" val="2466400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49AAC66-5B66-CDD8-6571-14D4FA5312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102" y="1357312"/>
            <a:ext cx="6067425" cy="34575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DEC2F6-1B53-8D8B-61D9-D199A18013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8840" y="1643062"/>
            <a:ext cx="5000625" cy="3171825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88ED2C2-F265-CCD0-C9A8-D504B1271BFE}"/>
              </a:ext>
            </a:extLst>
          </p:cNvPr>
          <p:cNvSpPr/>
          <p:nvPr/>
        </p:nvSpPr>
        <p:spPr>
          <a:xfrm>
            <a:off x="1565031" y="2110154"/>
            <a:ext cx="1063869" cy="8001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99938ED-33B2-CE19-B4AF-5FC0CEDD0865}"/>
              </a:ext>
            </a:extLst>
          </p:cNvPr>
          <p:cNvSpPr/>
          <p:nvPr/>
        </p:nvSpPr>
        <p:spPr>
          <a:xfrm>
            <a:off x="6986037" y="2285999"/>
            <a:ext cx="1063869" cy="8001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19E754-2512-DA36-53FE-547988DEE9D2}"/>
              </a:ext>
            </a:extLst>
          </p:cNvPr>
          <p:cNvSpPr txBox="1"/>
          <p:nvPr/>
        </p:nvSpPr>
        <p:spPr>
          <a:xfrm>
            <a:off x="1356030" y="980891"/>
            <a:ext cx="14818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2F940B7-3580-2953-23F3-41BB6997FFA9}"/>
              </a:ext>
            </a:extLst>
          </p:cNvPr>
          <p:cNvSpPr txBox="1"/>
          <p:nvPr/>
        </p:nvSpPr>
        <p:spPr>
          <a:xfrm>
            <a:off x="6777036" y="1273730"/>
            <a:ext cx="14818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Aptos" panose="02110004020202020204"/>
              </a:rPr>
              <a:t>Proband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1C68E9E-8238-A2BC-8A77-59DF939FE492}"/>
              </a:ext>
            </a:extLst>
          </p:cNvPr>
          <p:cNvSpPr txBox="1"/>
          <p:nvPr/>
        </p:nvSpPr>
        <p:spPr>
          <a:xfrm>
            <a:off x="413238" y="360485"/>
            <a:ext cx="1248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 2</a:t>
            </a:r>
          </a:p>
        </p:txBody>
      </p:sp>
    </p:spTree>
    <p:extLst>
      <p:ext uri="{BB962C8B-B14F-4D97-AF65-F5344CB8AC3E}">
        <p14:creationId xmlns:p14="http://schemas.microsoft.com/office/powerpoint/2010/main" val="274187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BF96904-7BAC-C666-8C83-3F0C3ED5F3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937" y="1228725"/>
            <a:ext cx="11668125" cy="440055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315E26C-355C-3AB3-AB05-708D8D21CDC4}"/>
              </a:ext>
            </a:extLst>
          </p:cNvPr>
          <p:cNvSpPr/>
          <p:nvPr/>
        </p:nvSpPr>
        <p:spPr>
          <a:xfrm>
            <a:off x="1406769" y="2400300"/>
            <a:ext cx="1178169" cy="3024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FB8D1BE-3E92-09AA-6D36-705A977FE6E4}"/>
              </a:ext>
            </a:extLst>
          </p:cNvPr>
          <p:cNvSpPr/>
          <p:nvPr/>
        </p:nvSpPr>
        <p:spPr>
          <a:xfrm>
            <a:off x="6227884" y="2183423"/>
            <a:ext cx="1178169" cy="3024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7B6B7F-5D59-DE45-8C99-3BF4D6680FC5}"/>
              </a:ext>
            </a:extLst>
          </p:cNvPr>
          <p:cNvSpPr txBox="1"/>
          <p:nvPr/>
        </p:nvSpPr>
        <p:spPr>
          <a:xfrm>
            <a:off x="1389184" y="859393"/>
            <a:ext cx="11781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33BA021-D820-DB70-B2D8-760D4615E230}"/>
              </a:ext>
            </a:extLst>
          </p:cNvPr>
          <p:cNvSpPr txBox="1"/>
          <p:nvPr/>
        </p:nvSpPr>
        <p:spPr>
          <a:xfrm>
            <a:off x="6095999" y="859393"/>
            <a:ext cx="15320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Aptos" panose="02110004020202020204"/>
              </a:rPr>
              <a:t>Proband 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2E110F-4346-0C48-25CF-69486A502D6E}"/>
              </a:ext>
            </a:extLst>
          </p:cNvPr>
          <p:cNvSpPr txBox="1"/>
          <p:nvPr/>
        </p:nvSpPr>
        <p:spPr>
          <a:xfrm>
            <a:off x="261937" y="120729"/>
            <a:ext cx="1248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 4</a:t>
            </a:r>
          </a:p>
        </p:txBody>
      </p:sp>
    </p:spTree>
    <p:extLst>
      <p:ext uri="{BB962C8B-B14F-4D97-AF65-F5344CB8AC3E}">
        <p14:creationId xmlns:p14="http://schemas.microsoft.com/office/powerpoint/2010/main" val="21254984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7A2277C-1C99-2F7D-76F4-F61793C11F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1173" y="839665"/>
            <a:ext cx="10848975" cy="58293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6D3DDB7-AA06-445C-B994-B5BF588F8AB6}"/>
              </a:ext>
            </a:extLst>
          </p:cNvPr>
          <p:cNvSpPr/>
          <p:nvPr/>
        </p:nvSpPr>
        <p:spPr>
          <a:xfrm>
            <a:off x="879231" y="2180491"/>
            <a:ext cx="1178169" cy="3024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2931F7E-77D2-3E22-D4EE-F11C05FE647C}"/>
              </a:ext>
            </a:extLst>
          </p:cNvPr>
          <p:cNvSpPr/>
          <p:nvPr/>
        </p:nvSpPr>
        <p:spPr>
          <a:xfrm>
            <a:off x="5776545" y="2180491"/>
            <a:ext cx="1178169" cy="3024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AC491B-B401-EF06-75E6-E99CCC1B5EB0}"/>
              </a:ext>
            </a:extLst>
          </p:cNvPr>
          <p:cNvSpPr txBox="1"/>
          <p:nvPr/>
        </p:nvSpPr>
        <p:spPr>
          <a:xfrm>
            <a:off x="772624" y="470333"/>
            <a:ext cx="13913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839EFA9-5EB8-4C81-0205-DA0BAA2BAA29}"/>
              </a:ext>
            </a:extLst>
          </p:cNvPr>
          <p:cNvSpPr txBox="1"/>
          <p:nvPr/>
        </p:nvSpPr>
        <p:spPr>
          <a:xfrm>
            <a:off x="5669938" y="470333"/>
            <a:ext cx="13913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Aptos" panose="02110004020202020204"/>
              </a:rPr>
              <a:t>Proband 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32642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6</Words>
  <Application>Microsoft Office PowerPoint</Application>
  <PresentationFormat>Widescreen</PresentationFormat>
  <Paragraphs>1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ildren's Hospital Colorad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iederich, Marisa</dc:creator>
  <cp:lastModifiedBy>Friederich, Marisa</cp:lastModifiedBy>
  <cp:revision>4</cp:revision>
  <dcterms:created xsi:type="dcterms:W3CDTF">2025-05-05T19:30:06Z</dcterms:created>
  <dcterms:modified xsi:type="dcterms:W3CDTF">2025-05-05T23:18:15Z</dcterms:modified>
</cp:coreProperties>
</file>